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成瀬 桂子" initials="成瀬" lastIdx="3" clrIdx="0">
    <p:extLst>
      <p:ext uri="{19B8F6BF-5375-455C-9EA6-DF929625EA0E}">
        <p15:presenceInfo xmlns:p15="http://schemas.microsoft.com/office/powerpoint/2012/main" userId="49390e128b0cd159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D7AC3CCA-C797-4891-BE02-D94E43425B78}" styleName="スタイル (中間)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C083E6E3-FA7D-4D7B-A595-EF9225AFEA82}" styleName="淡色スタイル 1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8EC20E35-A176-4012-BC5E-935CFFF8708E}" styleName="スタイル (中間)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E9639D4-E3E2-4D34-9284-5A2195B3D0D7}" styleName="スタイル (淡色)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793D81CF-94F2-401A-BA57-92F5A7B2D0C5}" styleName="スタイル (中間)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616DA210-FB5B-4158-B5E0-FEB733F419BA}" styleName="スタイル (淡色)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B301B821-A1FF-4177-AEE7-76D212191A09}" styleName="中間スタイル 1 - アクセント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713"/>
    <p:restoredTop sz="94697"/>
  </p:normalViewPr>
  <p:slideViewPr>
    <p:cSldViewPr snapToGrid="0" snapToObjects="1" showGuides="1">
      <p:cViewPr varScale="1">
        <p:scale>
          <a:sx n="161" d="100"/>
          <a:sy n="161" d="100"/>
        </p:scale>
        <p:origin x="1232" y="20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3D22F6D-7018-5347-98AE-1E9DFDC3ED0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500F6227-CB2A-1843-98F8-34E4F6021AA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815A5BB-E8F8-3E45-B176-7F383FEB46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8F8AE-2681-0142-A3E4-302432F56DFE}" type="datetimeFigureOut">
              <a:rPr kumimoji="1" lang="ja-JP" altLang="en-US" smtClean="0"/>
              <a:t>2021/4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C7CF478-AB0F-1C49-B743-DF782D1604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4C1B307-005B-B14A-9237-9D7BAFE706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0EE0E-2E1B-BA45-B3DF-2E0A2F9E55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12789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0E8C3CD-7F9D-2743-B410-E40756574A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674D5D0-A1C5-2743-8F4B-316B7911154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2BF887B-49D8-A347-BFEF-515F2695ED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8F8AE-2681-0142-A3E4-302432F56DFE}" type="datetimeFigureOut">
              <a:rPr kumimoji="1" lang="ja-JP" altLang="en-US" smtClean="0"/>
              <a:t>2021/4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E9727A4-AFFF-A749-82BA-F60799FDF8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F1D548C-EFF2-0C40-A39A-2AF42974D0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0EE0E-2E1B-BA45-B3DF-2E0A2F9E55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77815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68EB8AAC-9393-7946-A5BD-080868A4A16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98A88C8-1AE0-D247-AC76-5DA18897823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0F4F11F-40FA-6142-9D7B-9E9AF5B377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8F8AE-2681-0142-A3E4-302432F56DFE}" type="datetimeFigureOut">
              <a:rPr kumimoji="1" lang="ja-JP" altLang="en-US" smtClean="0"/>
              <a:t>2021/4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F9E17C2-34FA-874A-A118-B69908E3A3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BF47B56-55AE-174E-8237-C9157B7125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0EE0E-2E1B-BA45-B3DF-2E0A2F9E55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37873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A599523-4C87-8F41-996B-0A3B7BB5A9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DCD48FB-587A-FB4F-B62C-32E8BE3691B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F41CB14-9795-2045-B088-EBD1C372DB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8F8AE-2681-0142-A3E4-302432F56DFE}" type="datetimeFigureOut">
              <a:rPr kumimoji="1" lang="ja-JP" altLang="en-US" smtClean="0"/>
              <a:t>2021/4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7D7229F-66BF-8045-A11A-AFE42DA272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17DD9CC-36BE-6C42-A505-00D4322F8A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0EE0E-2E1B-BA45-B3DF-2E0A2F9E55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21909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DB92DE9-FAAB-974B-AFD9-56E3789C96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85E8BCC-4495-364B-9FD1-341D966B8F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FF62214-8064-224C-A895-861A07AD3B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8F8AE-2681-0142-A3E4-302432F56DFE}" type="datetimeFigureOut">
              <a:rPr kumimoji="1" lang="ja-JP" altLang="en-US" smtClean="0"/>
              <a:t>2021/4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212ECDF-F351-B84D-8FAD-3290AE1A2B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6575E7E-F2C5-5F41-ABFC-7EB28775D5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0EE0E-2E1B-BA45-B3DF-2E0A2F9E55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0865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F9F6977-C9FE-EE47-B539-9B447F419A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25BB6E6-023C-9B48-A1F6-1BA63706C81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C1240B5-F055-4340-A3DC-BF9F8CAA0D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7AF78DD-F7D3-6B41-AB17-37634BC1D7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8F8AE-2681-0142-A3E4-302432F56DFE}" type="datetimeFigureOut">
              <a:rPr kumimoji="1" lang="ja-JP" altLang="en-US" smtClean="0"/>
              <a:t>2021/4/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0DB6F59-5FA7-E748-8320-9E9E676E55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B3E02FD-BB83-D547-B18A-E85BB102D3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0EE0E-2E1B-BA45-B3DF-2E0A2F9E55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74732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2826E90-14F3-134B-9894-EBEC8EF130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CBE4167-612D-6D47-93AF-69865CFE35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00CA4B0-EC4C-C246-BEEC-6F1BE9903F9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F95B536D-3441-8548-A1C6-65AFEE17CAF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D39846A0-0FC4-7841-8AB4-0BC0ED00209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FF9F19BB-333D-EC40-8C58-072FFDF9CA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8F8AE-2681-0142-A3E4-302432F56DFE}" type="datetimeFigureOut">
              <a:rPr kumimoji="1" lang="ja-JP" altLang="en-US" smtClean="0"/>
              <a:t>2021/4/5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9954CF4B-6177-0049-935F-AF73698750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30308CED-67D4-D846-806D-3F67266760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0EE0E-2E1B-BA45-B3DF-2E0A2F9E55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20263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06E25BE-3EE5-9C4E-A122-133BAF9E57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6EC8308D-3DDD-A84B-ADDE-8E81CBD588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8F8AE-2681-0142-A3E4-302432F56DFE}" type="datetimeFigureOut">
              <a:rPr kumimoji="1" lang="ja-JP" altLang="en-US" smtClean="0"/>
              <a:t>2021/4/5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7425F25C-830B-7545-901E-1B562C17CF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4A2C7C1D-E77A-BC44-9AF2-6FFF80B421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0EE0E-2E1B-BA45-B3DF-2E0A2F9E55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39468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8A3CB97C-9C53-634B-8ACA-6B26621B7F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8F8AE-2681-0142-A3E4-302432F56DFE}" type="datetimeFigureOut">
              <a:rPr kumimoji="1" lang="ja-JP" altLang="en-US" smtClean="0"/>
              <a:t>2021/4/5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F8DC97C6-ED3D-9641-B3F3-B31D39050A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B0F077DA-003B-154B-894A-FF34CC476C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0EE0E-2E1B-BA45-B3DF-2E0A2F9E55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26334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94766C1-536D-B749-9937-A6DE5772FD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47587D1-8208-8440-95C1-27EA1E4875D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9E7F276-2EBD-9B4A-88F8-8F007402DD6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2E08AD9-D169-0D4A-BE82-6C11E1C84E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8F8AE-2681-0142-A3E4-302432F56DFE}" type="datetimeFigureOut">
              <a:rPr kumimoji="1" lang="ja-JP" altLang="en-US" smtClean="0"/>
              <a:t>2021/4/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60C8880-4349-5540-A729-109F69FF4A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D4C06D3-A506-024D-B3D6-5DA744F90D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0EE0E-2E1B-BA45-B3DF-2E0A2F9E55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07770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5278152-CEEB-8E4E-97E3-A4FCAA23C1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452F319E-F9C3-F341-A1AE-B8A421CB8F9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4EFAC84-A880-8042-857C-CC3CB333337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79C3BA5-4E2C-9041-9AFF-70DC4920F8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8F8AE-2681-0142-A3E4-302432F56DFE}" type="datetimeFigureOut">
              <a:rPr kumimoji="1" lang="ja-JP" altLang="en-US" smtClean="0"/>
              <a:t>2021/4/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5EACB57-89A7-4F4A-B42B-9DD6F3AA5D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CFEB20D-33EB-2C47-BD47-2CEA0377D4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0EE0E-2E1B-BA45-B3DF-2E0A2F9E55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67351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F6DD5E5F-E328-EF45-8834-95DD8825B4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8266638-04C8-0644-8297-2845E0A614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5E1B7B8-99B1-2545-B234-139411503F7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98F8AE-2681-0142-A3E4-302432F56DFE}" type="datetimeFigureOut">
              <a:rPr kumimoji="1" lang="ja-JP" altLang="en-US" smtClean="0"/>
              <a:t>2021/4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F128B9C-14BB-924B-B804-E0A11EDB9A0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C1B2DAF-015C-094B-9799-B6651BC305B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50EE0E-2E1B-BA45-B3DF-2E0A2F9E55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15423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4B5ABAD5-6CB9-1E42-9231-29AE26D7660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24120010"/>
              </p:ext>
            </p:extLst>
          </p:nvPr>
        </p:nvGraphicFramePr>
        <p:xfrm>
          <a:off x="1253398" y="931431"/>
          <a:ext cx="2557780" cy="3529330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1889125">
                  <a:extLst>
                    <a:ext uri="{9D8B030D-6E8A-4147-A177-3AD203B41FA5}">
                      <a16:colId xmlns:a16="http://schemas.microsoft.com/office/drawing/2014/main" val="128747204"/>
                    </a:ext>
                  </a:extLst>
                </a:gridCol>
                <a:gridCol w="668655">
                  <a:extLst>
                    <a:ext uri="{9D8B030D-6E8A-4147-A177-3AD203B41FA5}">
                      <a16:colId xmlns:a16="http://schemas.microsoft.com/office/drawing/2014/main" val="2220743719"/>
                    </a:ext>
                  </a:extLst>
                </a:gridCol>
              </a:tblGrid>
              <a:tr h="25209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effectLst/>
                        </a:rPr>
                        <a:t>Parameter (SI)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effectLst/>
                        </a:rPr>
                        <a:t>Value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77732015"/>
                  </a:ext>
                </a:extLst>
              </a:tr>
              <a:tr h="25209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effectLst/>
                        </a:rPr>
                        <a:t>C-reactive protein (</a:t>
                      </a:r>
                      <a:r>
                        <a:rPr lang="en-US" sz="1200" dirty="0" err="1">
                          <a:effectLst/>
                        </a:rPr>
                        <a:t>μg</a:t>
                      </a:r>
                      <a:r>
                        <a:rPr lang="en-US" sz="1200" dirty="0">
                          <a:effectLst/>
                        </a:rPr>
                        <a:t>/L)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</a:rPr>
                        <a:t>5100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867880497"/>
                  </a:ext>
                </a:extLst>
              </a:tr>
              <a:tr h="25209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effectLst/>
                        </a:rPr>
                        <a:t>ESR1hr (mm/h)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</a:rPr>
                        <a:t>10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3095029005"/>
                  </a:ext>
                </a:extLst>
              </a:tr>
              <a:tr h="25209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</a:rPr>
                        <a:t>ESR2hr (mm/h)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</a:rPr>
                        <a:t>24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2565599589"/>
                  </a:ext>
                </a:extLst>
              </a:tr>
              <a:tr h="25209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</a:rPr>
                        <a:t>RF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</a:rPr>
                        <a:t>Negative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1416070678"/>
                  </a:ext>
                </a:extLst>
              </a:tr>
              <a:tr h="25209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</a:rPr>
                        <a:t>IgG (g/L)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</a:rPr>
                        <a:t>10.94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1523589714"/>
                  </a:ext>
                </a:extLst>
              </a:tr>
              <a:tr h="25209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</a:rPr>
                        <a:t>IgM (g/L)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effectLst/>
                        </a:rPr>
                        <a:t>1.15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3857955429"/>
                  </a:ext>
                </a:extLst>
              </a:tr>
              <a:tr h="25209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</a:rPr>
                        <a:t>IgE (IU/mL)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</a:rPr>
                        <a:t>246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4225513270"/>
                  </a:ext>
                </a:extLst>
              </a:tr>
              <a:tr h="25209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</a:rPr>
                        <a:t>IgA (g/L)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</a:rPr>
                        <a:t>1.90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771949498"/>
                  </a:ext>
                </a:extLst>
              </a:tr>
              <a:tr h="25209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</a:rPr>
                        <a:t>Anti nuclear antibody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</a:rPr>
                        <a:t>Negative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1946611412"/>
                  </a:ext>
                </a:extLst>
              </a:tr>
              <a:tr h="25209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</a:rPr>
                        <a:t>C4 (g/L)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</a:rPr>
                        <a:t>0.26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929701254"/>
                  </a:ext>
                </a:extLst>
              </a:tr>
              <a:tr h="25209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</a:rPr>
                        <a:t>TSH (mIU/L)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</a:rPr>
                        <a:t>1.36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3349785826"/>
                  </a:ext>
                </a:extLst>
              </a:tr>
              <a:tr h="25209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</a:rPr>
                        <a:t>FT3 (pmol/L)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</a:rPr>
                        <a:t>4.424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2920994272"/>
                  </a:ext>
                </a:extLst>
              </a:tr>
              <a:tr h="25209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</a:rPr>
                        <a:t>FT4 (pmol/L)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effectLst/>
                        </a:rPr>
                        <a:t>0.1505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3943499597"/>
                  </a:ext>
                </a:extLst>
              </a:tr>
            </a:tbl>
          </a:graphicData>
        </a:graphic>
      </p:graphicFrame>
      <p:sp>
        <p:nvSpPr>
          <p:cNvPr id="3" name="Rectangle 1">
            <a:extLst>
              <a:ext uri="{FF2B5EF4-FFF2-40B4-BE49-F238E27FC236}">
                <a16:creationId xmlns:a16="http://schemas.microsoft.com/office/drawing/2014/main" id="{F895257B-D73F-8645-B6E4-86362C65529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54112" y="518547"/>
            <a:ext cx="5182573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Supplementary </a:t>
            </a: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Table 1. </a:t>
            </a:r>
            <a:r>
              <a:rPr lang="en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rious parameters supposed to be correlated to edema</a:t>
            </a:r>
            <a:endParaRPr kumimoji="0" lang="ja-JP" altLang="ja-JP" sz="18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032647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6</TotalTime>
  <Words>101</Words>
  <Application>Microsoft Macintosh PowerPoint</Application>
  <PresentationFormat>ワイド画面</PresentationFormat>
  <Paragraphs>2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User</dc:creator>
  <cp:lastModifiedBy>Microsoft Office User</cp:lastModifiedBy>
  <cp:revision>13</cp:revision>
  <cp:lastPrinted>2021-04-02T05:25:09Z</cp:lastPrinted>
  <dcterms:created xsi:type="dcterms:W3CDTF">2021-04-01T08:09:04Z</dcterms:created>
  <dcterms:modified xsi:type="dcterms:W3CDTF">2021-04-05T04:56:29Z</dcterms:modified>
</cp:coreProperties>
</file>